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26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CE9703D-E30C-4D97-9C6F-CE5612B396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49B5A1B9-A5D9-4206-9B21-3331FACDCAD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7739923-5563-4818-831D-07D5D6173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3C02-E84C-4DEB-8607-97835C729AE2}" type="datetimeFigureOut">
              <a:rPr lang="en-GB" smtClean="0"/>
              <a:t>27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D4B3DCE-1F4D-4059-87DA-E79DBD50B8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1517DEA-28B8-4167-B2B4-A73DFA345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D39D3-8402-45E7-9B06-643C04CED2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4661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18947B7-0F29-4519-9F90-6FB921A071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B78F4D14-72ED-43B6-8C20-C72ABF803A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8F26CE9-7C3E-45C9-BF3F-1A2A7BC96F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3C02-E84C-4DEB-8607-97835C729AE2}" type="datetimeFigureOut">
              <a:rPr lang="en-GB" smtClean="0"/>
              <a:t>27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8B84A2C-95AC-40A5-AD82-A6EA14C58A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F95806E-5974-4CF9-9D12-474FE5A6F7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D39D3-8402-45E7-9B06-643C04CED2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5424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0803FB95-37DD-47C1-A0A2-E4B5C18BFA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DD799AAF-A91A-4845-B61E-4B0CB27667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5E604EF-6F96-427A-967B-E8F12832D7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3C02-E84C-4DEB-8607-97835C729AE2}" type="datetimeFigureOut">
              <a:rPr lang="en-GB" smtClean="0"/>
              <a:t>27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C6F9FEC-8283-4A9C-9C87-2ABEA4777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9B112FC-B467-4118-AB3E-9A8406E8F6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D39D3-8402-45E7-9B06-643C04CED2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5196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8CDC08C-BABE-4840-8AB0-403DEC4393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38CF471-DD32-47FD-8920-261E8AFE72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2BB8303-6FCC-4910-86A9-B8BB892EC9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3C02-E84C-4DEB-8607-97835C729AE2}" type="datetimeFigureOut">
              <a:rPr lang="en-GB" smtClean="0"/>
              <a:t>27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2A0423F-27BC-45B5-816E-F66ACC567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8BB51BF-F779-4120-BB21-209D4700E3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D39D3-8402-45E7-9B06-643C04CED2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6851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6079DD2-A68A-47C4-8EBD-E957801CE5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29C2118-6CB7-4ACA-B6E9-0040CCE785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82706D3-295E-42A7-BE3E-578DF0CB91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3C02-E84C-4DEB-8607-97835C729AE2}" type="datetimeFigureOut">
              <a:rPr lang="en-GB" smtClean="0"/>
              <a:t>27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704DD29-528E-48BE-B457-0B72B48CE4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F3C424F-96B3-4290-95CB-12120BD2B6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D39D3-8402-45E7-9B06-643C04CED2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99007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5F96FDC-2C04-443F-AD72-30AFBB2AA1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E3234F2-6EAF-4905-9D04-F5C1E4DD8DD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3B26CF26-713A-44AF-B5EB-7A90CF0297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75F3C425-708E-401B-BAA9-E1957E99C8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3C02-E84C-4DEB-8607-97835C729AE2}" type="datetimeFigureOut">
              <a:rPr lang="en-GB" smtClean="0"/>
              <a:t>27/06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C4B0380-5580-42D6-B938-748E0BF38B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E9AF0BF-EEC3-4381-969B-937B027CD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D39D3-8402-45E7-9B06-643C04CED2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35743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DE541AC-9F79-47F3-8A83-078DB26D23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662F15CF-2760-4454-8D7C-451C1FD546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0E9F1B24-6387-408C-ADB2-5939AB7B06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A170F920-2468-4AC4-AC32-E9AA6DF006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E48E3C23-2F6E-4086-9897-6930E27628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09C2D7B8-A1F2-462A-8B9E-99D807B0BE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3C02-E84C-4DEB-8607-97835C729AE2}" type="datetimeFigureOut">
              <a:rPr lang="en-GB" smtClean="0"/>
              <a:t>27/06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ED63CB0E-ACBB-4EDF-8214-AFA430B5E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95C7EB31-CCDF-4CD2-A667-52BC4F2F6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D39D3-8402-45E7-9B06-643C04CED2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58975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D7859F5-35D7-48BD-ADC2-1EE3382864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F1B055E9-FECE-4487-8C6A-9CD7E3653F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3C02-E84C-4DEB-8607-97835C729AE2}" type="datetimeFigureOut">
              <a:rPr lang="en-GB" smtClean="0"/>
              <a:t>27/06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2736A352-A8C0-4362-AAA1-1167AA84E6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014789FA-FCE5-487E-A44A-E971BC9DA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D39D3-8402-45E7-9B06-643C04CED2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9083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8AC5C93D-1D69-4521-8B73-0302FE88C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3C02-E84C-4DEB-8607-97835C729AE2}" type="datetimeFigureOut">
              <a:rPr lang="en-GB" smtClean="0"/>
              <a:t>27/06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4012E6D7-0F48-4AAA-9B75-DF130B7369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5CCF73A4-E58E-40F1-B392-276546AC96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D39D3-8402-45E7-9B06-643C04CED2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506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7AEDFD1-A25D-4795-94F0-5D2D6B4EA6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DAF2FE5-FFC8-4A0C-A429-EE1E0291D0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0533470-32DB-4FE5-A816-DBFF37223A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87843C9-5D45-4D82-B931-5319C1E417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3C02-E84C-4DEB-8607-97835C729AE2}" type="datetimeFigureOut">
              <a:rPr lang="en-GB" smtClean="0"/>
              <a:t>27/06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070C25C-07DB-45A6-BCFC-74A49FD87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EDCAE1EC-DA64-461B-8A74-81472BF897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D39D3-8402-45E7-9B06-643C04CED2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7510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302F508-63FB-4758-8250-88AA14DF41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26765FAA-EE7E-4474-A8F8-1E517C6EA2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4A81D4AA-9198-424B-8352-48ABF0BA79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7EF60C71-926A-4D52-9BF2-14A69D46C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3C02-E84C-4DEB-8607-97835C729AE2}" type="datetimeFigureOut">
              <a:rPr lang="en-GB" smtClean="0"/>
              <a:t>27/06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2ADE905F-FC9A-43B9-B838-DBC307116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C6AE7BC-7E6D-493D-82C7-737910C5D3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D39D3-8402-45E7-9B06-643C04CED2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0443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19B0EE4B-7DED-466F-8405-150EF1B5AD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D0BC536-85D4-446B-9588-47225DDD28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1937522-27D5-46BC-8AB5-46EC8DA184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33C02-E84C-4DEB-8607-97835C729AE2}" type="datetimeFigureOut">
              <a:rPr lang="en-GB" smtClean="0"/>
              <a:t>27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8252C85-EEB7-468B-9582-F859BD99DC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9CF6EA4-EBD1-49C9-86CB-9758A842587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2D39D3-8402-45E7-9B06-643C04CED2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78498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3.png"/><Relationship Id="rId7" Type="http://schemas.openxmlformats.org/officeDocument/2006/relationships/image" Target="../media/image6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5" Type="http://schemas.openxmlformats.org/officeDocument/2006/relationships/image" Target="../media/image5.png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&#10;&#10;Description automatically generated with medium confidence">
            <a:extLst>
              <a:ext uri="{FF2B5EF4-FFF2-40B4-BE49-F238E27FC236}">
                <a16:creationId xmlns:a16="http://schemas.microsoft.com/office/drawing/2014/main" xmlns="" id="{13BD33D2-3AAD-45CD-9DC7-6D87829453E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630"/>
          <a:stretch/>
        </p:blipFill>
        <p:spPr>
          <a:xfrm>
            <a:off x="215901" y="1250670"/>
            <a:ext cx="4094554" cy="5154280"/>
          </a:xfrm>
          <a:prstGeom prst="rect">
            <a:avLst/>
          </a:prstGeom>
        </p:spPr>
      </p:pic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xmlns="" id="{7136586D-F3EF-47BC-B7C7-2C278BF697FB}"/>
              </a:ext>
            </a:extLst>
          </p:cNvPr>
          <p:cNvCxnSpPr/>
          <p:nvPr/>
        </p:nvCxnSpPr>
        <p:spPr>
          <a:xfrm>
            <a:off x="1629448" y="4091545"/>
            <a:ext cx="2304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7911AEEF-092E-4BD8-8B12-883B2CE98BB0}"/>
              </a:ext>
            </a:extLst>
          </p:cNvPr>
          <p:cNvSpPr txBox="1"/>
          <p:nvPr/>
        </p:nvSpPr>
        <p:spPr>
          <a:xfrm>
            <a:off x="516965" y="182636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Supplementary Figure 1</a:t>
            </a:r>
            <a:endParaRPr lang="en-GB" sz="1200" dirty="0"/>
          </a:p>
        </p:txBody>
      </p:sp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319E933A-E77D-4C3E-8C7E-95A450E40D1A}"/>
              </a:ext>
            </a:extLst>
          </p:cNvPr>
          <p:cNvSpPr txBox="1"/>
          <p:nvPr/>
        </p:nvSpPr>
        <p:spPr>
          <a:xfrm>
            <a:off x="0" y="1066004"/>
            <a:ext cx="400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.</a:t>
            </a:r>
            <a:r>
              <a:rPr lang="en-GB" sz="1200" b="1" dirty="0"/>
              <a:t> 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8743913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D499FBAD-77F4-4249-A0AE-6168E5BEE80B}"/>
              </a:ext>
            </a:extLst>
          </p:cNvPr>
          <p:cNvSpPr txBox="1"/>
          <p:nvPr/>
        </p:nvSpPr>
        <p:spPr>
          <a:xfrm>
            <a:off x="356092" y="163219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Supplementary </a:t>
            </a:r>
            <a:r>
              <a:rPr lang="en-GB" sz="1200" b="1"/>
              <a:t>Figure </a:t>
            </a:r>
            <a:r>
              <a:rPr lang="en-GB" sz="1200" b="1" smtClean="0"/>
              <a:t>2</a:t>
            </a:r>
            <a:endParaRPr lang="en-GB" sz="1200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xmlns="" id="{00D492A8-093B-4C0B-9554-CEC1EF29F65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6589" y="1034768"/>
            <a:ext cx="2737929" cy="2053447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25BE7125-FD73-4BEB-AF67-CA094E0F46B6}"/>
              </a:ext>
            </a:extLst>
          </p:cNvPr>
          <p:cNvSpPr txBox="1"/>
          <p:nvPr/>
        </p:nvSpPr>
        <p:spPr>
          <a:xfrm>
            <a:off x="3219614" y="757769"/>
            <a:ext cx="1055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rimary BC </a:t>
            </a:r>
            <a:r>
              <a:rPr lang="en-GB" sz="800" dirty="0"/>
              <a:t>x10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xmlns="" id="{B0F81E9D-7C34-4C42-82EA-4D4BC7FE24A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7874" y="1034768"/>
            <a:ext cx="2737929" cy="2053447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1CBE320C-814D-49C8-B572-D97486311397}"/>
              </a:ext>
            </a:extLst>
          </p:cNvPr>
          <p:cNvSpPr txBox="1"/>
          <p:nvPr/>
        </p:nvSpPr>
        <p:spPr>
          <a:xfrm>
            <a:off x="6050307" y="757769"/>
            <a:ext cx="1055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rimary BC </a:t>
            </a:r>
            <a:r>
              <a:rPr lang="en-GB" sz="800" dirty="0"/>
              <a:t>x40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xmlns="" id="{8C508646-F75A-40D2-BB71-CD58BDB9577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2649" y="3469718"/>
            <a:ext cx="2749864" cy="2062398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ED8C09C3-A7B8-4252-9251-0D8D2E5BD7F4}"/>
              </a:ext>
            </a:extLst>
          </p:cNvPr>
          <p:cNvSpPr txBox="1"/>
          <p:nvPr/>
        </p:nvSpPr>
        <p:spPr>
          <a:xfrm>
            <a:off x="3194849" y="3192719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BCBM </a:t>
            </a:r>
            <a:r>
              <a:rPr lang="en-GB" sz="800" dirty="0"/>
              <a:t>x1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D643676A-CC89-4024-9279-169F5F0446F9}"/>
              </a:ext>
            </a:extLst>
          </p:cNvPr>
          <p:cNvSpPr txBox="1"/>
          <p:nvPr/>
        </p:nvSpPr>
        <p:spPr>
          <a:xfrm>
            <a:off x="6025542" y="3192719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BCBM </a:t>
            </a:r>
            <a:r>
              <a:rPr lang="en-GB" sz="800" dirty="0"/>
              <a:t>x40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xmlns="" id="{CD9984C1-72A4-40BD-B352-751A948B3E7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7260" y="3478209"/>
            <a:ext cx="2738543" cy="2053907"/>
          </a:xfrm>
          <a:prstGeom prst="rect">
            <a:avLst/>
          </a:prstGeom>
        </p:spPr>
      </p:pic>
      <p:sp>
        <p:nvSpPr>
          <p:cNvPr id="21" name="Oval 20">
            <a:extLst>
              <a:ext uri="{FF2B5EF4-FFF2-40B4-BE49-F238E27FC236}">
                <a16:creationId xmlns:a16="http://schemas.microsoft.com/office/drawing/2014/main" xmlns="" id="{1181619D-C794-4349-BD10-3742431AF86C}"/>
              </a:ext>
            </a:extLst>
          </p:cNvPr>
          <p:cNvSpPr/>
          <p:nvPr/>
        </p:nvSpPr>
        <p:spPr>
          <a:xfrm>
            <a:off x="5163917" y="4303775"/>
            <a:ext cx="757649" cy="585965"/>
          </a:xfrm>
          <a:prstGeom prst="ellipse">
            <a:avLst/>
          </a:prstGeom>
          <a:noFill/>
          <a:ln w="6350">
            <a:solidFill>
              <a:schemeClr val="accent4">
                <a:lumMod val="50000"/>
              </a:schemeClr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xmlns="" id="{B269D90A-AA5C-467E-9722-CC67BEB17A1B}"/>
              </a:ext>
            </a:extLst>
          </p:cNvPr>
          <p:cNvCxnSpPr>
            <a:stCxn id="21" idx="0"/>
          </p:cNvCxnSpPr>
          <p:nvPr/>
        </p:nvCxnSpPr>
        <p:spPr>
          <a:xfrm flipV="1">
            <a:off x="5542742" y="3478209"/>
            <a:ext cx="907139" cy="825566"/>
          </a:xfrm>
          <a:prstGeom prst="line">
            <a:avLst/>
          </a:prstGeom>
          <a:ln w="6350">
            <a:solidFill>
              <a:schemeClr val="accent4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xmlns="" id="{F7E9F8A2-B9F4-4E36-965A-CF6AA2BA1CF2}"/>
              </a:ext>
            </a:extLst>
          </p:cNvPr>
          <p:cNvCxnSpPr>
            <a:stCxn id="21" idx="4"/>
          </p:cNvCxnSpPr>
          <p:nvPr/>
        </p:nvCxnSpPr>
        <p:spPr>
          <a:xfrm>
            <a:off x="5542742" y="4889740"/>
            <a:ext cx="907139" cy="642376"/>
          </a:xfrm>
          <a:prstGeom prst="line">
            <a:avLst/>
          </a:prstGeom>
          <a:ln w="6350">
            <a:solidFill>
              <a:schemeClr val="accent4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Oval 23">
            <a:extLst>
              <a:ext uri="{FF2B5EF4-FFF2-40B4-BE49-F238E27FC236}">
                <a16:creationId xmlns:a16="http://schemas.microsoft.com/office/drawing/2014/main" xmlns="" id="{E4875D12-F1DA-47AB-B3C4-D5C8D87A35B7}"/>
              </a:ext>
            </a:extLst>
          </p:cNvPr>
          <p:cNvSpPr/>
          <p:nvPr/>
        </p:nvSpPr>
        <p:spPr>
          <a:xfrm>
            <a:off x="4080056" y="1534330"/>
            <a:ext cx="757550" cy="634653"/>
          </a:xfrm>
          <a:prstGeom prst="ellipse">
            <a:avLst/>
          </a:prstGeom>
          <a:noFill/>
          <a:ln w="6350">
            <a:solidFill>
              <a:schemeClr val="accent4">
                <a:lumMod val="50000"/>
              </a:schemeClr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xmlns="" id="{389F41B1-1356-4E59-A3DF-92D81903315C}"/>
              </a:ext>
            </a:extLst>
          </p:cNvPr>
          <p:cNvCxnSpPr/>
          <p:nvPr/>
        </p:nvCxnSpPr>
        <p:spPr>
          <a:xfrm flipH="1" flipV="1">
            <a:off x="4427129" y="2168984"/>
            <a:ext cx="2022752" cy="914986"/>
          </a:xfrm>
          <a:prstGeom prst="line">
            <a:avLst/>
          </a:prstGeom>
          <a:ln w="6350">
            <a:solidFill>
              <a:schemeClr val="accent4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xmlns="" id="{6DF261D7-133C-4127-B926-C50D880E2640}"/>
              </a:ext>
            </a:extLst>
          </p:cNvPr>
          <p:cNvCxnSpPr/>
          <p:nvPr/>
        </p:nvCxnSpPr>
        <p:spPr>
          <a:xfrm flipV="1">
            <a:off x="4458831" y="1034768"/>
            <a:ext cx="1991050" cy="499562"/>
          </a:xfrm>
          <a:prstGeom prst="line">
            <a:avLst/>
          </a:prstGeom>
          <a:ln w="6350">
            <a:solidFill>
              <a:schemeClr val="accent4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446" y="3482454"/>
            <a:ext cx="2738543" cy="205390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446" y="1039014"/>
            <a:ext cx="2737837" cy="2053378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25BE7125-FD73-4BEB-AF67-CA094E0F46B6}"/>
              </a:ext>
            </a:extLst>
          </p:cNvPr>
          <p:cNvSpPr txBox="1"/>
          <p:nvPr/>
        </p:nvSpPr>
        <p:spPr>
          <a:xfrm>
            <a:off x="356092" y="762014"/>
            <a:ext cx="20548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rimary BC-Non metastatic </a:t>
            </a:r>
            <a:r>
              <a:rPr lang="en-GB" sz="800" dirty="0"/>
              <a:t>x1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25BE7125-FD73-4BEB-AF67-CA094E0F46B6}"/>
              </a:ext>
            </a:extLst>
          </p:cNvPr>
          <p:cNvSpPr txBox="1"/>
          <p:nvPr/>
        </p:nvSpPr>
        <p:spPr>
          <a:xfrm>
            <a:off x="356092" y="3227037"/>
            <a:ext cx="1983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rostate (positive control) </a:t>
            </a:r>
            <a:r>
              <a:rPr lang="en-GB" sz="800" dirty="0"/>
              <a:t>x10</a:t>
            </a:r>
          </a:p>
        </p:txBody>
      </p:sp>
    </p:spTree>
    <p:extLst>
      <p:ext uri="{BB962C8B-B14F-4D97-AF65-F5344CB8AC3E}">
        <p14:creationId xmlns:p14="http://schemas.microsoft.com/office/powerpoint/2010/main" val="8806712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1</TotalTime>
  <Words>28</Words>
  <Application>Microsoft Office PowerPoint</Application>
  <PresentationFormat>Widescreen</PresentationFormat>
  <Paragraphs>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itor</dc:creator>
  <cp:lastModifiedBy>Giannoudis, Athina</cp:lastModifiedBy>
  <cp:revision>21</cp:revision>
  <cp:lastPrinted>2021-12-07T10:15:46Z</cp:lastPrinted>
  <dcterms:created xsi:type="dcterms:W3CDTF">2021-11-29T22:04:48Z</dcterms:created>
  <dcterms:modified xsi:type="dcterms:W3CDTF">2022-06-27T11:57:11Z</dcterms:modified>
</cp:coreProperties>
</file>